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3EA6E-0B65-4171-AD78-8EDB9F959F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66B39-6BB7-46FD-8FC5-3E0991043E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EB13A-2889-473B-88FF-401EC620FF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8085E-05DF-4D29-B375-F57A1B15E7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C263A-8AB3-4D43-AC32-7CF17A157C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89882-1F67-414B-9332-A27CF01615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9C792-F61C-453D-932C-9E655E4112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B518C-AC5E-4E59-B929-A5E4144359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82B78-F2E3-41C9-99B2-9D04645DD9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1DC4C-0DA8-4948-B791-384C34D3EE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20215-BD26-4578-B90D-9EF5C4BA98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60C8C-B308-438A-8F58-E5694E813E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C45E14-5A3D-4A75-8C21-CD2A600077E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69800" y="95256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4920" y="1268280"/>
            <a:ext cx="903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-34560" y="952560"/>
            <a:ext cx="57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ti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6720" y="13413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6720" y="17002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6720" y="311292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6720" y="278136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6720" y="239220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720" y="206064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29080" y="95256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Diag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774440" y="952560"/>
            <a:ext cx="92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n 12 mut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276720" y="95256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714840" y="95256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142160" y="95256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567680" y="95256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Wb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068800" y="952560"/>
            <a:ext cx="36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Tr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454720" y="95256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p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504680" y="708120"/>
            <a:ext cx="128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At time of diagn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366240" y="95256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Thromb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7730280" y="95256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7135200" y="95256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8462880" y="95256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Treat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789880" y="952560"/>
            <a:ext cx="57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340080" y="952560"/>
            <a:ext cx="353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41800" y="13413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41440" y="170028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41440" y="206064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260360" y="95256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Yea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41440" y="311292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41800" y="27813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41800" y="239220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946440" y="13413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946440" y="17002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946440" y="20606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946440" y="23922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946440" y="27957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946440" y="3112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296720" y="31129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366560" y="27813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620720" y="2392200"/>
            <a:ext cx="123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537-I540delins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765440" y="1700280"/>
            <a:ext cx="98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542-E543d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937880" y="311292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539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657800" y="2060640"/>
            <a:ext cx="111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536-I546dup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765440" y="1312920"/>
            <a:ext cx="98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542-E543d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783080" y="2781360"/>
            <a:ext cx="98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542-E543d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349440" y="31129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349440" y="2781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646160" y="3112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567040" y="3112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709440" y="31129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026400" y="31129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141440" y="31129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7812000" y="314172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051160" y="3112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6529680" y="31129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148160" y="3112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579160" y="3141720"/>
            <a:ext cx="38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,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0" y="335772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0" y="191628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0" y="227664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0" y="263700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0" y="299736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0" y="155736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646160" y="27813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568120" y="278136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lo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709440" y="27813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026400" y="278136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141440" y="27813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7812000" y="280980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051160" y="27813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6529680" y="278136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915240" y="2781360"/>
            <a:ext cx="87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yperplas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8579160" y="2809800"/>
            <a:ext cx="38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,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7812000" y="239220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7812000" y="206064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7812000" y="167328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7812000" y="134136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605800" y="13413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8534520" y="17002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u, 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8605800" y="206064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8604360" y="242100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8091360" y="95256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Seq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8172360" y="314172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8172360" y="280980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8172360" y="239220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8172360" y="206064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8172360" y="167328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8172360" y="1341360"/>
            <a:ext cx="3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158160" y="304020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349440" y="1671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349440" y="13399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646160" y="16714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5567040" y="16714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709440" y="167148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026400" y="167148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141440" y="167148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5051160" y="167148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6529680" y="167148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646160" y="1339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5568120" y="133992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lo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709440" y="13399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6026400" y="133992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4141440" y="13399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.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5051160" y="13399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6529680" y="13399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6915240" y="1339920"/>
            <a:ext cx="87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yperplas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349440" y="23922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349440" y="20606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576320" y="23922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.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567040" y="23922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709440" y="23922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6026400" y="239220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141440" y="239220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.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051160" y="239220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529680" y="239220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6932880" y="2421000"/>
            <a:ext cx="87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yperplas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574520" y="206064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rm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5567040" y="20606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/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709440" y="20606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026400" y="20606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141440" y="20606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5052240" y="206064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rm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529680" y="20606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6932880" y="2060640"/>
            <a:ext cx="87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yperplas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366560" y="23922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296720" y="20606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368360" y="16714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366560" y="13399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6932880" y="1671480"/>
            <a:ext cx="87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000" spc="-1" strike="noStrike">
                <a:solidFill>
                  <a:srgbClr val="000000"/>
                </a:solidFill>
                <a:latin typeface="Arial"/>
              </a:rPr>
              <a:t>Hyperplas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6158160" y="198900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2772000" y="952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mut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2" name=""/>
          <p:cNvGraphicFramePr/>
          <p:nvPr/>
        </p:nvGraphicFramePr>
        <p:xfrm>
          <a:off x="2925720" y="1341360"/>
          <a:ext cx="360360" cy="243000"/>
        </p:xfrm>
        <a:graphic>
          <a:graphicData uri="http://schemas.openxmlformats.org/drawingml/2006/table">
            <a:tbl>
              <a:tblPr/>
              <a:tblGrid>
                <a:gridCol w="36036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73" name=""/>
          <p:cNvGraphicFramePr/>
          <p:nvPr/>
        </p:nvGraphicFramePr>
        <p:xfrm>
          <a:off x="2844720" y="1700280"/>
          <a:ext cx="503280" cy="243000"/>
        </p:xfrm>
        <a:graphic>
          <a:graphicData uri="http://schemas.openxmlformats.org/drawingml/2006/table">
            <a:tbl>
              <a:tblPr/>
              <a:tblGrid>
                <a:gridCol w="50328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74" name=""/>
          <p:cNvGraphicFramePr/>
          <p:nvPr/>
        </p:nvGraphicFramePr>
        <p:xfrm>
          <a:off x="2800440" y="2060640"/>
          <a:ext cx="609480" cy="243000"/>
        </p:xfrm>
        <a:graphic>
          <a:graphicData uri="http://schemas.openxmlformats.org/drawingml/2006/table">
            <a:tbl>
              <a:tblPr/>
              <a:tblGrid>
                <a:gridCol w="60948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75" name=""/>
          <p:cNvGraphicFramePr/>
          <p:nvPr/>
        </p:nvGraphicFramePr>
        <p:xfrm>
          <a:off x="2890800" y="2394000"/>
          <a:ext cx="432000" cy="243000"/>
        </p:xfrm>
        <a:graphic>
          <a:graphicData uri="http://schemas.openxmlformats.org/drawingml/2006/table">
            <a:tbl>
              <a:tblPr/>
              <a:tblGrid>
                <a:gridCol w="43200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76" name=""/>
          <p:cNvGraphicFramePr/>
          <p:nvPr/>
        </p:nvGraphicFramePr>
        <p:xfrm>
          <a:off x="2882880" y="2781360"/>
          <a:ext cx="432000" cy="243000"/>
        </p:xfrm>
        <a:graphic>
          <a:graphicData uri="http://schemas.openxmlformats.org/drawingml/2006/table">
            <a:tbl>
              <a:tblPr/>
              <a:tblGrid>
                <a:gridCol w="43200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77" name=""/>
          <p:cNvGraphicFramePr/>
          <p:nvPr/>
        </p:nvGraphicFramePr>
        <p:xfrm>
          <a:off x="2887560" y="3125880"/>
          <a:ext cx="432000" cy="242640"/>
        </p:xfrm>
        <a:graphic>
          <a:graphicData uri="http://schemas.openxmlformats.org/drawingml/2006/table">
            <a:tbl>
              <a:tblPr/>
              <a:tblGrid>
                <a:gridCol w="43200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1T12:33:47Z</dcterms:created>
  <dc:creator>laskja01</dc:creator>
  <dc:description/>
  <dc:language>en-US</dc:language>
  <cp:lastModifiedBy>laskja01</cp:lastModifiedBy>
  <dcterms:modified xsi:type="dcterms:W3CDTF">2012-01-03T13:49:25Z</dcterms:modified>
  <cp:revision>34</cp:revision>
  <dc:subject/>
  <dc:title>Dias nummer 1</dc:title>
</cp:coreProperties>
</file>